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2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7A67-9D06-401B-9F82-80DDBBD77FE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DC163-3B27-4A59-80B7-A745F27B3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2172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7A67-9D06-401B-9F82-80DDBBD77FE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DC163-3B27-4A59-80B7-A745F27B3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9666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7A67-9D06-401B-9F82-80DDBBD77FE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DC163-3B27-4A59-80B7-A745F27B3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942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7A67-9D06-401B-9F82-80DDBBD77FE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DC163-3B27-4A59-80B7-A745F27B3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03510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7A67-9D06-401B-9F82-80DDBBD77FE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DC163-3B27-4A59-80B7-A745F27B3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9819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7A67-9D06-401B-9F82-80DDBBD77FE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DC163-3B27-4A59-80B7-A745F27B3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6061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7A67-9D06-401B-9F82-80DDBBD77FE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DC163-3B27-4A59-80B7-A745F27B3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0558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7A67-9D06-401B-9F82-80DDBBD77FE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DC163-3B27-4A59-80B7-A745F27B3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0105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7A67-9D06-401B-9F82-80DDBBD77FE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DC163-3B27-4A59-80B7-A745F27B3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225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7A67-9D06-401B-9F82-80DDBBD77FE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DC163-3B27-4A59-80B7-A745F27B3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6313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F7A67-9D06-401B-9F82-80DDBBD77FE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DC163-3B27-4A59-80B7-A745F27B3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419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EF7A67-9D06-401B-9F82-80DDBBD77FE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4DC163-3B27-4A59-80B7-A745F27B37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7931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330" y="978264"/>
            <a:ext cx="3789812" cy="2841173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51599" y="359575"/>
            <a:ext cx="5392401" cy="1941453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51599" y="2398850"/>
            <a:ext cx="5242560" cy="2141460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170388" y="960969"/>
            <a:ext cx="35705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812559" y="359575"/>
            <a:ext cx="33092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812559" y="2365719"/>
            <a:ext cx="28738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7E2A754-E4B8-4C3F-81D0-F88066D73194}"/>
              </a:ext>
            </a:extLst>
          </p:cNvPr>
          <p:cNvSpPr txBox="1"/>
          <p:nvPr/>
        </p:nvSpPr>
        <p:spPr>
          <a:xfrm>
            <a:off x="527439" y="4790114"/>
            <a:ext cx="815516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Supplementary Fig. 3</a:t>
            </a:r>
            <a:r>
              <a:rPr lang="en-US" altLang="ja-JP" sz="1200" dirty="0"/>
              <a:t>. Transfection of </a:t>
            </a:r>
            <a:r>
              <a:rPr lang="en-US" altLang="ja-JP" sz="1200" i="1" dirty="0"/>
              <a:t>IMMT</a:t>
            </a:r>
            <a:r>
              <a:rPr lang="en-US" altLang="ja-JP" sz="1200" dirty="0"/>
              <a:t> siRNA and proliferation, migration, and invasion assays. Cell proliferation of IMMT-knockdown A549 cells at 72 hours was significantly decreased to approximately 30% of levels observed with </a:t>
            </a:r>
            <a:r>
              <a:rPr lang="en-US" altLang="ja-JP" sz="1200" dirty="0" err="1"/>
              <a:t>siControl</a:t>
            </a:r>
            <a:r>
              <a:rPr lang="en-US" altLang="ja-JP" sz="1200" dirty="0"/>
              <a:t> A549 cells (P &lt; 0.003) (A). No significant differences were observed in terms of migration and invasion in IMMT-knockdown A549 cells compared to those in </a:t>
            </a:r>
            <a:r>
              <a:rPr lang="en-US" altLang="ja-JP" sz="1200" dirty="0" err="1"/>
              <a:t>siControl</a:t>
            </a:r>
            <a:r>
              <a:rPr lang="en-US" altLang="ja-JP" sz="1200" dirty="0"/>
              <a:t> cells (B, C). </a:t>
            </a:r>
            <a:endParaRPr lang="ja-JP" altLang="ja-JP" sz="1200" dirty="0"/>
          </a:p>
          <a:p>
            <a:endParaRPr kumimoji="1" lang="ja-JP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78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雄一</dc:creator>
  <cp:lastModifiedBy>佐藤 雄一</cp:lastModifiedBy>
  <cp:revision>2</cp:revision>
  <dcterms:created xsi:type="dcterms:W3CDTF">2019-03-27T13:13:15Z</dcterms:created>
  <dcterms:modified xsi:type="dcterms:W3CDTF">2019-05-31T07:45:34Z</dcterms:modified>
</cp:coreProperties>
</file>